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8096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8096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496880" y="1200240"/>
            <a:ext cx="4321440" cy="3240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6840" rIns="9684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620960"/>
            <a:ext cx="5851440" cy="377964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8096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8096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B54E06-7274-4C75-9C26-D32468906446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sldImg"/>
          </p:nvPr>
        </p:nvSpPr>
        <p:spPr>
          <a:xfrm>
            <a:off x="1496880" y="1200240"/>
            <a:ext cx="4321440" cy="3240000"/>
          </a:xfrm>
          <a:prstGeom prst="rect">
            <a:avLst/>
          </a:prstGeom>
          <a:ln w="0">
            <a:noFill/>
          </a:ln>
        </p:spPr>
      </p:sp>
      <p:sp>
        <p:nvSpPr>
          <p:cNvPr id="66" name="PlaceHolder 2"/>
          <p:cNvSpPr>
            <a:spLocks noGrp="1"/>
          </p:cNvSpPr>
          <p:nvPr>
            <p:ph type="body"/>
          </p:nvPr>
        </p:nvSpPr>
        <p:spPr>
          <a:xfrm>
            <a:off x="731880" y="4620960"/>
            <a:ext cx="5851440" cy="377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Slide Number Placeholder 3"/>
          <p:cNvSpPr/>
          <p:nvPr/>
        </p:nvSpPr>
        <p:spPr>
          <a:xfrm>
            <a:off x="4143240" y="9120240"/>
            <a:ext cx="3170520" cy="48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840" rIns="96840" tIns="48240" bIns="482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8B0822-0321-4A81-A17F-7C3BC242A64B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9103C-D825-43E3-85E8-239EB7E138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753B3A-5916-45CD-972B-6AF86B1CBB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AC6D39-1E38-4F80-A296-1A7EE657A1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BBDC4-1E4C-41F0-8C42-B1167568A1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892EA2-2096-4EF9-A6FB-C26520B407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C5B21A-B416-44E8-A553-DBCA2E23FB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97167F-802B-4603-9F16-84FE9CF2F6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422B9-5574-4455-AD59-8F468511FC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A34100-2C5A-44E9-9BA9-A66590AC42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27C78-4968-47C7-965C-D6AB61AFA9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A422C-D013-4398-A0FC-74A0F2B810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B5B8B3-0EB6-471F-8480-D0950924D7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80C2BB-A1CD-49A9-AA8F-11E19D50634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"/>
          <p:cNvPicPr/>
          <p:nvPr/>
        </p:nvPicPr>
        <p:blipFill>
          <a:blip r:embed="rId1"/>
          <a:stretch/>
        </p:blipFill>
        <p:spPr>
          <a:xfrm>
            <a:off x="55440" y="36360"/>
            <a:ext cx="9033120" cy="576108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4"/>
          <p:cNvSpPr/>
          <p:nvPr/>
        </p:nvSpPr>
        <p:spPr>
          <a:xfrm>
            <a:off x="82440" y="5762520"/>
            <a:ext cx="8991720" cy="114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CR amplicons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oFLC1.C9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BoFLC3.C3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oFLC4.C3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late-flowering line BN3848 (P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early-flowering line BN623 (P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PCR products with respective  primers from start to stop codons of the genes (Table S1A ) were run on a 1.5% agarose gel and their corresponding amplicon sizes are mentioned. M is a 100-bp size marker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2" descr="D:\Netbook D drive\Yusuf 2nd paper\BMC genetics\Figure  2.jpg"/>
          <p:cNvPicPr/>
          <p:nvPr/>
        </p:nvPicPr>
        <p:blipFill>
          <a:blip r:embed="rId1"/>
          <a:stretch/>
        </p:blipFill>
        <p:spPr>
          <a:xfrm>
            <a:off x="61920" y="1592280"/>
            <a:ext cx="9037800" cy="3457440"/>
          </a:xfrm>
          <a:prstGeom prst="rect">
            <a:avLst/>
          </a:prstGeom>
          <a:ln w="0">
            <a:noFill/>
          </a:ln>
        </p:spPr>
      </p:pic>
      <p:sp>
        <p:nvSpPr>
          <p:cNvPr id="51" name="Rectangle 3"/>
          <p:cNvSpPr/>
          <p:nvPr/>
        </p:nvSpPr>
        <p:spPr>
          <a:xfrm>
            <a:off x="152280" y="5365800"/>
            <a:ext cx="87631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quence alignments of the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oFLC1.C9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cloned from early- and late-flowering lines. Variation of a 67-bp insertion in the early-flowering line BN623 is highlighted in red color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3" descr=""/>
          <p:cNvPicPr/>
          <p:nvPr/>
        </p:nvPicPr>
        <p:blipFill>
          <a:blip r:embed="rId1"/>
          <a:stretch/>
        </p:blipFill>
        <p:spPr>
          <a:xfrm>
            <a:off x="533520" y="169920"/>
            <a:ext cx="8229600" cy="5492520"/>
          </a:xfrm>
          <a:prstGeom prst="rect">
            <a:avLst/>
          </a:prstGeom>
          <a:ln w="0">
            <a:noFill/>
          </a:ln>
        </p:spPr>
      </p:pic>
      <p:sp>
        <p:nvSpPr>
          <p:cNvPr id="53" name="Rectangle 42"/>
          <p:cNvSpPr/>
          <p:nvPr/>
        </p:nvSpPr>
        <p:spPr>
          <a:xfrm>
            <a:off x="55440" y="5754600"/>
            <a:ext cx="9006120" cy="93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CR-amplicons of 141 F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egregating population with F7R7 marker of BoFLC1.C9 gene. P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Late-flowering parent (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BN3848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P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Early –flowering parent (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BN623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F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(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BN3848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× 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BN623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; black and red colored numbers of the F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dividual are matched and mismatched lines, respectively as early- and late-flowering lines. M=100 bp DNA marker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"/>
          <p:cNvSpPr/>
          <p:nvPr/>
        </p:nvSpPr>
        <p:spPr>
          <a:xfrm>
            <a:off x="-73080" y="533520"/>
            <a:ext cx="6825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7920" algn="ctr">
              <a:lnSpc>
                <a:spcPct val="107000"/>
              </a:lnSpc>
              <a:spcBef>
                <a:spcPts val="74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8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"/>
          <p:cNvSpPr/>
          <p:nvPr/>
        </p:nvSpPr>
        <p:spPr>
          <a:xfrm>
            <a:off x="-80280" y="1371600"/>
            <a:ext cx="6825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7920" algn="ctr">
              <a:lnSpc>
                <a:spcPct val="107000"/>
              </a:lnSpc>
              <a:spcBef>
                <a:spcPts val="74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8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"/>
          <p:cNvSpPr/>
          <p:nvPr/>
        </p:nvSpPr>
        <p:spPr>
          <a:xfrm>
            <a:off x="-77040" y="2208240"/>
            <a:ext cx="6825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7920" algn="ctr">
              <a:lnSpc>
                <a:spcPct val="107000"/>
              </a:lnSpc>
              <a:spcBef>
                <a:spcPts val="74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8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"/>
          <p:cNvSpPr/>
          <p:nvPr/>
        </p:nvSpPr>
        <p:spPr>
          <a:xfrm>
            <a:off x="-80280" y="2960640"/>
            <a:ext cx="6825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7920" algn="ctr">
              <a:lnSpc>
                <a:spcPct val="107000"/>
              </a:lnSpc>
              <a:spcBef>
                <a:spcPts val="74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8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"/>
          <p:cNvSpPr/>
          <p:nvPr/>
        </p:nvSpPr>
        <p:spPr>
          <a:xfrm>
            <a:off x="-80280" y="3749760"/>
            <a:ext cx="6825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7920" algn="ctr">
              <a:lnSpc>
                <a:spcPct val="107000"/>
              </a:lnSpc>
              <a:spcBef>
                <a:spcPts val="74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8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"/>
          <p:cNvSpPr/>
          <p:nvPr/>
        </p:nvSpPr>
        <p:spPr>
          <a:xfrm>
            <a:off x="-83520" y="4548240"/>
            <a:ext cx="6825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7920" algn="ctr">
              <a:lnSpc>
                <a:spcPct val="107000"/>
              </a:lnSpc>
              <a:spcBef>
                <a:spcPts val="74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8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"/>
          <p:cNvSpPr/>
          <p:nvPr/>
        </p:nvSpPr>
        <p:spPr>
          <a:xfrm>
            <a:off x="-77040" y="5373720"/>
            <a:ext cx="6825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7920" algn="ctr">
              <a:lnSpc>
                <a:spcPct val="107000"/>
              </a:lnSpc>
              <a:spcBef>
                <a:spcPts val="74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8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Rectangle 42"/>
          <p:cNvSpPr/>
          <p:nvPr/>
        </p:nvSpPr>
        <p:spPr>
          <a:xfrm>
            <a:off x="152280" y="6161040"/>
            <a:ext cx="8686800" cy="64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gression and correlation coefficient between marker dosage and  phenotypes as days to flowering after sowing (DAS) explained by the F7R7 marker in 141 F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dividual. ** indicates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&lt; 0.0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Chart 4" descr=""/>
          <p:cNvPicPr/>
          <p:nvPr/>
        </p:nvPicPr>
        <p:blipFill>
          <a:blip r:embed="rId1"/>
          <a:stretch/>
        </p:blipFill>
        <p:spPr>
          <a:xfrm>
            <a:off x="927000" y="414360"/>
            <a:ext cx="7558200" cy="5425920"/>
          </a:xfrm>
          <a:prstGeom prst="rect">
            <a:avLst/>
          </a:prstGeom>
          <a:ln w="0">
            <a:noFill/>
          </a:ln>
        </p:spPr>
      </p:pic>
      <p:sp>
        <p:nvSpPr>
          <p:cNvPr id="63" name="TextBox 3"/>
          <p:cNvSpPr/>
          <p:nvPr/>
        </p:nvSpPr>
        <p:spPr>
          <a:xfrm>
            <a:off x="5334120" y="1447920"/>
            <a:ext cx="1193760" cy="35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 = 0.83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4"/>
          <p:cNvSpPr/>
          <p:nvPr/>
        </p:nvSpPr>
        <p:spPr>
          <a:xfrm>
            <a:off x="1828800" y="457200"/>
            <a:ext cx="1828800" cy="685800"/>
          </a:xfrm>
          <a:prstGeom prst="rect">
            <a:avLst/>
          </a:prstGeom>
          <a:solidFill>
            <a:srgbClr val="ffffff"/>
          </a:solidFill>
          <a:ln w="9360">
            <a:solidFill>
              <a:srgbClr val="bcbcb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 - Homozygous for earl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 - Heterozygo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 - Homozygous lor lat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4-02T08:14:04Z</dcterms:created>
  <dc:creator>super</dc:creator>
  <dc:description/>
  <dc:language>en-US</dc:language>
  <cp:lastModifiedBy>Ujjal Nath</cp:lastModifiedBy>
  <cp:lastPrinted>2018-11-29T03:42:51Z</cp:lastPrinted>
  <dcterms:modified xsi:type="dcterms:W3CDTF">2019-03-13T21:00:27Z</dcterms:modified>
  <cp:revision>31</cp:revision>
  <dc:subject/>
  <dc:title>Slide 1</dc:title>
</cp:coreProperties>
</file>